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chu\Documents\CIHI%20HCV%20data\Hep%20C%20Ontario%20Prevalenc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onthly</a:t>
            </a:r>
            <a:r>
              <a:rPr lang="en-US" baseline="0" dirty="0"/>
              <a:t> r</a:t>
            </a:r>
            <a:r>
              <a:rPr lang="en-US" dirty="0"/>
              <a:t>ate of HCV-specific hospitalizations per 1,000,000 of HCV</a:t>
            </a:r>
            <a:r>
              <a:rPr lang="en-US" baseline="0" dirty="0"/>
              <a:t> patient population in Ontario</a:t>
            </a:r>
            <a:r>
              <a:rPr lang="en-US" dirty="0"/>
              <a:t>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3"/>
          <c:order val="0"/>
          <c:tx>
            <c:strRef>
              <c:f>Graphs!$E$1</c:f>
              <c:strCache>
                <c:ptCount val="1"/>
                <c:pt idx="0">
                  <c:v>Rate of Hosp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cat>
            <c:numRef>
              <c:f>Graphs!$A$2:$A$169</c:f>
              <c:numCache>
                <c:formatCode>[$-409]mmmm\ d\,\ yyyy;@</c:formatCode>
                <c:ptCount val="168"/>
                <c:pt idx="0">
                  <c:v>38808</c:v>
                </c:pt>
                <c:pt idx="1">
                  <c:v>38838</c:v>
                </c:pt>
                <c:pt idx="2">
                  <c:v>38869</c:v>
                </c:pt>
                <c:pt idx="3">
                  <c:v>38899</c:v>
                </c:pt>
                <c:pt idx="4">
                  <c:v>38930</c:v>
                </c:pt>
                <c:pt idx="5">
                  <c:v>38961</c:v>
                </c:pt>
                <c:pt idx="6">
                  <c:v>38991</c:v>
                </c:pt>
                <c:pt idx="7">
                  <c:v>39022</c:v>
                </c:pt>
                <c:pt idx="8">
                  <c:v>39052</c:v>
                </c:pt>
                <c:pt idx="9">
                  <c:v>39083</c:v>
                </c:pt>
                <c:pt idx="10">
                  <c:v>39114</c:v>
                </c:pt>
                <c:pt idx="11">
                  <c:v>39142</c:v>
                </c:pt>
                <c:pt idx="12">
                  <c:v>39173</c:v>
                </c:pt>
                <c:pt idx="13">
                  <c:v>39203</c:v>
                </c:pt>
                <c:pt idx="14">
                  <c:v>39234</c:v>
                </c:pt>
                <c:pt idx="15">
                  <c:v>39264</c:v>
                </c:pt>
                <c:pt idx="16">
                  <c:v>39295</c:v>
                </c:pt>
                <c:pt idx="17">
                  <c:v>39326</c:v>
                </c:pt>
                <c:pt idx="18">
                  <c:v>39356</c:v>
                </c:pt>
                <c:pt idx="19">
                  <c:v>39387</c:v>
                </c:pt>
                <c:pt idx="20">
                  <c:v>39417</c:v>
                </c:pt>
                <c:pt idx="21">
                  <c:v>39448</c:v>
                </c:pt>
                <c:pt idx="22">
                  <c:v>39479</c:v>
                </c:pt>
                <c:pt idx="23">
                  <c:v>39508</c:v>
                </c:pt>
                <c:pt idx="24">
                  <c:v>39539</c:v>
                </c:pt>
                <c:pt idx="25">
                  <c:v>39569</c:v>
                </c:pt>
                <c:pt idx="26">
                  <c:v>39600</c:v>
                </c:pt>
                <c:pt idx="27">
                  <c:v>39630</c:v>
                </c:pt>
                <c:pt idx="28">
                  <c:v>39661</c:v>
                </c:pt>
                <c:pt idx="29">
                  <c:v>39692</c:v>
                </c:pt>
                <c:pt idx="30">
                  <c:v>39722</c:v>
                </c:pt>
                <c:pt idx="31">
                  <c:v>39753</c:v>
                </c:pt>
                <c:pt idx="32">
                  <c:v>39783</c:v>
                </c:pt>
                <c:pt idx="33">
                  <c:v>39814</c:v>
                </c:pt>
                <c:pt idx="34">
                  <c:v>39845</c:v>
                </c:pt>
                <c:pt idx="35">
                  <c:v>39873</c:v>
                </c:pt>
                <c:pt idx="36">
                  <c:v>39904</c:v>
                </c:pt>
                <c:pt idx="37">
                  <c:v>39934</c:v>
                </c:pt>
                <c:pt idx="38">
                  <c:v>39965</c:v>
                </c:pt>
                <c:pt idx="39">
                  <c:v>39995</c:v>
                </c:pt>
                <c:pt idx="40">
                  <c:v>40026</c:v>
                </c:pt>
                <c:pt idx="41">
                  <c:v>40057</c:v>
                </c:pt>
                <c:pt idx="42">
                  <c:v>40087</c:v>
                </c:pt>
                <c:pt idx="43">
                  <c:v>40118</c:v>
                </c:pt>
                <c:pt idx="44">
                  <c:v>40148</c:v>
                </c:pt>
                <c:pt idx="45">
                  <c:v>40179</c:v>
                </c:pt>
                <c:pt idx="46">
                  <c:v>40210</c:v>
                </c:pt>
                <c:pt idx="47">
                  <c:v>40238</c:v>
                </c:pt>
                <c:pt idx="48">
                  <c:v>40269</c:v>
                </c:pt>
                <c:pt idx="49">
                  <c:v>40299</c:v>
                </c:pt>
                <c:pt idx="50">
                  <c:v>40330</c:v>
                </c:pt>
                <c:pt idx="51">
                  <c:v>40360</c:v>
                </c:pt>
                <c:pt idx="52">
                  <c:v>40391</c:v>
                </c:pt>
                <c:pt idx="53">
                  <c:v>40422</c:v>
                </c:pt>
                <c:pt idx="54">
                  <c:v>40452</c:v>
                </c:pt>
                <c:pt idx="55">
                  <c:v>40483</c:v>
                </c:pt>
                <c:pt idx="56">
                  <c:v>40513</c:v>
                </c:pt>
                <c:pt idx="57">
                  <c:v>40544</c:v>
                </c:pt>
                <c:pt idx="58">
                  <c:v>40575</c:v>
                </c:pt>
                <c:pt idx="59">
                  <c:v>40603</c:v>
                </c:pt>
                <c:pt idx="60">
                  <c:v>40634</c:v>
                </c:pt>
                <c:pt idx="61">
                  <c:v>40664</c:v>
                </c:pt>
                <c:pt idx="62">
                  <c:v>40695</c:v>
                </c:pt>
                <c:pt idx="63">
                  <c:v>40725</c:v>
                </c:pt>
                <c:pt idx="64">
                  <c:v>40756</c:v>
                </c:pt>
                <c:pt idx="65">
                  <c:v>40787</c:v>
                </c:pt>
                <c:pt idx="66">
                  <c:v>40817</c:v>
                </c:pt>
                <c:pt idx="67">
                  <c:v>40848</c:v>
                </c:pt>
                <c:pt idx="68">
                  <c:v>40878</c:v>
                </c:pt>
                <c:pt idx="69">
                  <c:v>40909</c:v>
                </c:pt>
                <c:pt idx="70">
                  <c:v>40940</c:v>
                </c:pt>
                <c:pt idx="71">
                  <c:v>40969</c:v>
                </c:pt>
                <c:pt idx="72">
                  <c:v>41000</c:v>
                </c:pt>
                <c:pt idx="73">
                  <c:v>41030</c:v>
                </c:pt>
                <c:pt idx="74">
                  <c:v>41061</c:v>
                </c:pt>
                <c:pt idx="75">
                  <c:v>41091</c:v>
                </c:pt>
                <c:pt idx="76">
                  <c:v>41122</c:v>
                </c:pt>
                <c:pt idx="77">
                  <c:v>41153</c:v>
                </c:pt>
                <c:pt idx="78">
                  <c:v>41183</c:v>
                </c:pt>
                <c:pt idx="79">
                  <c:v>41214</c:v>
                </c:pt>
                <c:pt idx="80">
                  <c:v>41244</c:v>
                </c:pt>
                <c:pt idx="81">
                  <c:v>41275</c:v>
                </c:pt>
                <c:pt idx="82">
                  <c:v>41306</c:v>
                </c:pt>
                <c:pt idx="83">
                  <c:v>41334</c:v>
                </c:pt>
                <c:pt idx="84">
                  <c:v>41365</c:v>
                </c:pt>
                <c:pt idx="85">
                  <c:v>41395</c:v>
                </c:pt>
                <c:pt idx="86">
                  <c:v>41426</c:v>
                </c:pt>
                <c:pt idx="87">
                  <c:v>41456</c:v>
                </c:pt>
                <c:pt idx="88">
                  <c:v>41487</c:v>
                </c:pt>
                <c:pt idx="89">
                  <c:v>41518</c:v>
                </c:pt>
                <c:pt idx="90">
                  <c:v>41548</c:v>
                </c:pt>
                <c:pt idx="91">
                  <c:v>41579</c:v>
                </c:pt>
                <c:pt idx="92">
                  <c:v>41609</c:v>
                </c:pt>
                <c:pt idx="93">
                  <c:v>41640</c:v>
                </c:pt>
                <c:pt idx="94">
                  <c:v>41671</c:v>
                </c:pt>
                <c:pt idx="95">
                  <c:v>41699</c:v>
                </c:pt>
                <c:pt idx="96">
                  <c:v>41730</c:v>
                </c:pt>
                <c:pt idx="97">
                  <c:v>41760</c:v>
                </c:pt>
                <c:pt idx="98">
                  <c:v>41791</c:v>
                </c:pt>
                <c:pt idx="99">
                  <c:v>41821</c:v>
                </c:pt>
                <c:pt idx="100">
                  <c:v>41852</c:v>
                </c:pt>
                <c:pt idx="101">
                  <c:v>41883</c:v>
                </c:pt>
                <c:pt idx="102">
                  <c:v>41913</c:v>
                </c:pt>
                <c:pt idx="103">
                  <c:v>41944</c:v>
                </c:pt>
                <c:pt idx="104">
                  <c:v>41974</c:v>
                </c:pt>
                <c:pt idx="105">
                  <c:v>42005</c:v>
                </c:pt>
                <c:pt idx="106">
                  <c:v>42036</c:v>
                </c:pt>
                <c:pt idx="107">
                  <c:v>42064</c:v>
                </c:pt>
                <c:pt idx="108">
                  <c:v>42095</c:v>
                </c:pt>
                <c:pt idx="109">
                  <c:v>42125</c:v>
                </c:pt>
                <c:pt idx="110">
                  <c:v>42156</c:v>
                </c:pt>
                <c:pt idx="111">
                  <c:v>42186</c:v>
                </c:pt>
                <c:pt idx="112">
                  <c:v>42217</c:v>
                </c:pt>
                <c:pt idx="113">
                  <c:v>42248</c:v>
                </c:pt>
                <c:pt idx="114">
                  <c:v>42278</c:v>
                </c:pt>
                <c:pt idx="115">
                  <c:v>42309</c:v>
                </c:pt>
                <c:pt idx="116">
                  <c:v>42339</c:v>
                </c:pt>
                <c:pt idx="117">
                  <c:v>42370</c:v>
                </c:pt>
                <c:pt idx="118">
                  <c:v>42401</c:v>
                </c:pt>
                <c:pt idx="119">
                  <c:v>42430</c:v>
                </c:pt>
                <c:pt idx="120">
                  <c:v>42461</c:v>
                </c:pt>
                <c:pt idx="121">
                  <c:v>42491</c:v>
                </c:pt>
                <c:pt idx="122">
                  <c:v>42522</c:v>
                </c:pt>
                <c:pt idx="123">
                  <c:v>42552</c:v>
                </c:pt>
                <c:pt idx="124">
                  <c:v>42583</c:v>
                </c:pt>
                <c:pt idx="125">
                  <c:v>42614</c:v>
                </c:pt>
                <c:pt idx="126">
                  <c:v>42644</c:v>
                </c:pt>
                <c:pt idx="127">
                  <c:v>42675</c:v>
                </c:pt>
                <c:pt idx="128">
                  <c:v>42705</c:v>
                </c:pt>
                <c:pt idx="129">
                  <c:v>42736</c:v>
                </c:pt>
                <c:pt idx="130">
                  <c:v>42767</c:v>
                </c:pt>
                <c:pt idx="131">
                  <c:v>42795</c:v>
                </c:pt>
                <c:pt idx="132">
                  <c:v>42826</c:v>
                </c:pt>
                <c:pt idx="133">
                  <c:v>42856</c:v>
                </c:pt>
                <c:pt idx="134">
                  <c:v>42887</c:v>
                </c:pt>
                <c:pt idx="135">
                  <c:v>42917</c:v>
                </c:pt>
                <c:pt idx="136">
                  <c:v>42948</c:v>
                </c:pt>
                <c:pt idx="137">
                  <c:v>42979</c:v>
                </c:pt>
                <c:pt idx="138">
                  <c:v>43009</c:v>
                </c:pt>
                <c:pt idx="139">
                  <c:v>43040</c:v>
                </c:pt>
                <c:pt idx="140">
                  <c:v>43070</c:v>
                </c:pt>
                <c:pt idx="141">
                  <c:v>43101</c:v>
                </c:pt>
                <c:pt idx="142">
                  <c:v>43132</c:v>
                </c:pt>
                <c:pt idx="143">
                  <c:v>43160</c:v>
                </c:pt>
                <c:pt idx="144">
                  <c:v>43191</c:v>
                </c:pt>
                <c:pt idx="145">
                  <c:v>43221</c:v>
                </c:pt>
                <c:pt idx="146">
                  <c:v>43252</c:v>
                </c:pt>
                <c:pt idx="147">
                  <c:v>43282</c:v>
                </c:pt>
                <c:pt idx="148">
                  <c:v>43313</c:v>
                </c:pt>
                <c:pt idx="149">
                  <c:v>43344</c:v>
                </c:pt>
                <c:pt idx="150">
                  <c:v>43374</c:v>
                </c:pt>
                <c:pt idx="151">
                  <c:v>43405</c:v>
                </c:pt>
                <c:pt idx="152">
                  <c:v>43435</c:v>
                </c:pt>
                <c:pt idx="153">
                  <c:v>43466</c:v>
                </c:pt>
                <c:pt idx="154">
                  <c:v>43497</c:v>
                </c:pt>
                <c:pt idx="155">
                  <c:v>43525</c:v>
                </c:pt>
                <c:pt idx="156">
                  <c:v>43556</c:v>
                </c:pt>
                <c:pt idx="157">
                  <c:v>43586</c:v>
                </c:pt>
                <c:pt idx="158">
                  <c:v>43617</c:v>
                </c:pt>
                <c:pt idx="159">
                  <c:v>43647</c:v>
                </c:pt>
                <c:pt idx="160">
                  <c:v>43678</c:v>
                </c:pt>
                <c:pt idx="161">
                  <c:v>43709</c:v>
                </c:pt>
                <c:pt idx="162">
                  <c:v>43739</c:v>
                </c:pt>
                <c:pt idx="163">
                  <c:v>43770</c:v>
                </c:pt>
                <c:pt idx="164">
                  <c:v>43800</c:v>
                </c:pt>
                <c:pt idx="165">
                  <c:v>43831</c:v>
                </c:pt>
                <c:pt idx="166">
                  <c:v>43862</c:v>
                </c:pt>
                <c:pt idx="167">
                  <c:v>43891</c:v>
                </c:pt>
              </c:numCache>
            </c:numRef>
          </c:cat>
          <c:val>
            <c:numRef>
              <c:f>Graphs!$E$2:$E$169</c:f>
              <c:numCache>
                <c:formatCode>General</c:formatCode>
                <c:ptCount val="168"/>
                <c:pt idx="0">
                  <c:v>4751.6072736263586</c:v>
                </c:pt>
                <c:pt idx="1">
                  <c:v>5320.8878649588823</c:v>
                </c:pt>
                <c:pt idx="2">
                  <c:v>5209.373446952357</c:v>
                </c:pt>
                <c:pt idx="3">
                  <c:v>5227.7915295575949</c:v>
                </c:pt>
                <c:pt idx="4">
                  <c:v>5228.5356574656735</c:v>
                </c:pt>
                <c:pt idx="5">
                  <c:v>5107.1362308844291</c:v>
                </c:pt>
                <c:pt idx="6">
                  <c:v>5230.0245489812696</c:v>
                </c:pt>
                <c:pt idx="7">
                  <c:v>5062.7738019947474</c:v>
                </c:pt>
                <c:pt idx="8">
                  <c:v>5178.0535587421873</c:v>
                </c:pt>
                <c:pt idx="9">
                  <c:v>5385.0261769158706</c:v>
                </c:pt>
                <c:pt idx="10">
                  <c:v>4835.7548720584145</c:v>
                </c:pt>
                <c:pt idx="11">
                  <c:v>4928.1300236602974</c:v>
                </c:pt>
                <c:pt idx="12">
                  <c:v>4623.1682787822256</c:v>
                </c:pt>
                <c:pt idx="13">
                  <c:v>4983.0335979202282</c:v>
                </c:pt>
                <c:pt idx="14">
                  <c:v>5006.6752347938309</c:v>
                </c:pt>
                <c:pt idx="15">
                  <c:v>5359.0529671800732</c:v>
                </c:pt>
                <c:pt idx="16">
                  <c:v>5336.3843183899562</c:v>
                </c:pt>
                <c:pt idx="17">
                  <c:v>4648.5435297523627</c:v>
                </c:pt>
                <c:pt idx="18">
                  <c:v>5398.0844078973014</c:v>
                </c:pt>
                <c:pt idx="19">
                  <c:v>5558.9277479948769</c:v>
                </c:pt>
                <c:pt idx="20">
                  <c:v>4970.4032498715551</c:v>
                </c:pt>
                <c:pt idx="21">
                  <c:v>5054.7697513014555</c:v>
                </c:pt>
                <c:pt idx="22">
                  <c:v>5032.0791512090336</c:v>
                </c:pt>
                <c:pt idx="23">
                  <c:v>5147.0488124422445</c:v>
                </c:pt>
                <c:pt idx="24">
                  <c:v>5139.6571493762058</c:v>
                </c:pt>
                <c:pt idx="25">
                  <c:v>5224.0489175545226</c:v>
                </c:pt>
                <c:pt idx="26">
                  <c:v>5277.8528538358396</c:v>
                </c:pt>
                <c:pt idx="27">
                  <c:v>5660.5882291133667</c:v>
                </c:pt>
                <c:pt idx="28">
                  <c:v>5171.5196878933402</c:v>
                </c:pt>
                <c:pt idx="29">
                  <c:v>5279.1283788742394</c:v>
                </c:pt>
                <c:pt idx="30">
                  <c:v>5371.4544219191621</c:v>
                </c:pt>
                <c:pt idx="31">
                  <c:v>5310.7506082676618</c:v>
                </c:pt>
                <c:pt idx="32">
                  <c:v>5081.6666743010719</c:v>
                </c:pt>
                <c:pt idx="33">
                  <c:v>5005.6157191445336</c:v>
                </c:pt>
                <c:pt idx="34">
                  <c:v>5036.7143047814825</c:v>
                </c:pt>
                <c:pt idx="35">
                  <c:v>5266.8570613719239</c:v>
                </c:pt>
                <c:pt idx="36">
                  <c:v>4892.2160286103772</c:v>
                </c:pt>
                <c:pt idx="37">
                  <c:v>5566.4826156619329</c:v>
                </c:pt>
                <c:pt idx="38">
                  <c:v>5367.9213796356989</c:v>
                </c:pt>
                <c:pt idx="39">
                  <c:v>5896.8562343080439</c:v>
                </c:pt>
                <c:pt idx="40">
                  <c:v>5429.6342937979016</c:v>
                </c:pt>
                <c:pt idx="41">
                  <c:v>5598.0432630721034</c:v>
                </c:pt>
                <c:pt idx="42">
                  <c:v>5950.2391607500876</c:v>
                </c:pt>
                <c:pt idx="43">
                  <c:v>5659.1651900721108</c:v>
                </c:pt>
                <c:pt idx="44">
                  <c:v>5888.8270848502389</c:v>
                </c:pt>
                <c:pt idx="45">
                  <c:v>5498.211431055709</c:v>
                </c:pt>
                <c:pt idx="46">
                  <c:v>5613.0058731912841</c:v>
                </c:pt>
                <c:pt idx="47">
                  <c:v>6095.3566165473821</c:v>
                </c:pt>
                <c:pt idx="48">
                  <c:v>5903.845176277654</c:v>
                </c:pt>
                <c:pt idx="49">
                  <c:v>5819.5406243000498</c:v>
                </c:pt>
                <c:pt idx="50">
                  <c:v>5919.010848394475</c:v>
                </c:pt>
                <c:pt idx="51">
                  <c:v>6378.362145331861</c:v>
                </c:pt>
                <c:pt idx="52">
                  <c:v>5919.432064376364</c:v>
                </c:pt>
                <c:pt idx="53">
                  <c:v>5567.6424210864116</c:v>
                </c:pt>
                <c:pt idx="54">
                  <c:v>5805.5385144554684</c:v>
                </c:pt>
                <c:pt idx="55">
                  <c:v>6112.4114408285477</c:v>
                </c:pt>
                <c:pt idx="56">
                  <c:v>5729.9083195326612</c:v>
                </c:pt>
                <c:pt idx="57">
                  <c:v>5584.8304562417852</c:v>
                </c:pt>
                <c:pt idx="58">
                  <c:v>5554.6521144448507</c:v>
                </c:pt>
                <c:pt idx="59">
                  <c:v>5930.5669692719493</c:v>
                </c:pt>
                <c:pt idx="60">
                  <c:v>5501.9431278828615</c:v>
                </c:pt>
                <c:pt idx="61">
                  <c:v>5701.6557221209514</c:v>
                </c:pt>
                <c:pt idx="62">
                  <c:v>6230.9606016449316</c:v>
                </c:pt>
                <c:pt idx="63">
                  <c:v>6062.8573658721853</c:v>
                </c:pt>
                <c:pt idx="64">
                  <c:v>6586.6273724101729</c:v>
                </c:pt>
                <c:pt idx="65">
                  <c:v>5793.2805260584028</c:v>
                </c:pt>
                <c:pt idx="66">
                  <c:v>5765.8630194937205</c:v>
                </c:pt>
                <c:pt idx="67">
                  <c:v>5860.7459140499423</c:v>
                </c:pt>
                <c:pt idx="68">
                  <c:v>6245.6212912121191</c:v>
                </c:pt>
                <c:pt idx="69">
                  <c:v>5790.6750041308924</c:v>
                </c:pt>
                <c:pt idx="70">
                  <c:v>5481.2755618766487</c:v>
                </c:pt>
                <c:pt idx="71">
                  <c:v>6025.5239518728677</c:v>
                </c:pt>
                <c:pt idx="72">
                  <c:v>5906.7134169789178</c:v>
                </c:pt>
                <c:pt idx="73">
                  <c:v>6122.7448473247805</c:v>
                </c:pt>
                <c:pt idx="74">
                  <c:v>5874.8412250533393</c:v>
                </c:pt>
                <c:pt idx="75">
                  <c:v>5277.9838773525235</c:v>
                </c:pt>
                <c:pt idx="76">
                  <c:v>5985.0439917974581</c:v>
                </c:pt>
                <c:pt idx="77">
                  <c:v>5719.9731233883313</c:v>
                </c:pt>
                <c:pt idx="78">
                  <c:v>6115.7930710580722</c:v>
                </c:pt>
                <c:pt idx="79">
                  <c:v>5721.4983408186699</c:v>
                </c:pt>
                <c:pt idx="80">
                  <c:v>5988.2362133092247</c:v>
                </c:pt>
                <c:pt idx="81">
                  <c:v>5738.2249677984501</c:v>
                </c:pt>
                <c:pt idx="82">
                  <c:v>5457.741783992672</c:v>
                </c:pt>
                <c:pt idx="83">
                  <c:v>5998.2349406846342</c:v>
                </c:pt>
                <c:pt idx="84">
                  <c:v>5953.4151423813983</c:v>
                </c:pt>
                <c:pt idx="85">
                  <c:v>6707.0405973912711</c:v>
                </c:pt>
                <c:pt idx="86">
                  <c:v>6190.7705349239031</c:v>
                </c:pt>
                <c:pt idx="87">
                  <c:v>6450.2138585138837</c:v>
                </c:pt>
                <c:pt idx="88">
                  <c:v>5858.2798958867561</c:v>
                </c:pt>
                <c:pt idx="89">
                  <c:v>6011.84310108932</c:v>
                </c:pt>
                <c:pt idx="90">
                  <c:v>6386.2171969313367</c:v>
                </c:pt>
                <c:pt idx="91">
                  <c:v>6075.553040805592</c:v>
                </c:pt>
                <c:pt idx="92">
                  <c:v>6328.2725297274137</c:v>
                </c:pt>
                <c:pt idx="93">
                  <c:v>6185.024550895102</c:v>
                </c:pt>
                <c:pt idx="94">
                  <c:v>6186.4669895085717</c:v>
                </c:pt>
                <c:pt idx="95">
                  <c:v>6218.3924168435851</c:v>
                </c:pt>
                <c:pt idx="96">
                  <c:v>6326.5563121104387</c:v>
                </c:pt>
                <c:pt idx="97">
                  <c:v>6572.0051395896016</c:v>
                </c:pt>
                <c:pt idx="98">
                  <c:v>6047.3510815447235</c:v>
                </c:pt>
                <c:pt idx="99">
                  <c:v>6323.360121105602</c:v>
                </c:pt>
                <c:pt idx="100">
                  <c:v>5608.2882545535022</c:v>
                </c:pt>
                <c:pt idx="101">
                  <c:v>5343.0677704632872</c:v>
                </c:pt>
                <c:pt idx="102">
                  <c:v>6383.3495391192419</c:v>
                </c:pt>
                <c:pt idx="103">
                  <c:v>5751.5789097444303</c:v>
                </c:pt>
                <c:pt idx="104">
                  <c:v>6112.6834010320508</c:v>
                </c:pt>
                <c:pt idx="105">
                  <c:v>5847.2708582139649</c:v>
                </c:pt>
                <c:pt idx="106">
                  <c:v>5505.213747915881</c:v>
                </c:pt>
                <c:pt idx="107">
                  <c:v>6210.8019835586183</c:v>
                </c:pt>
                <c:pt idx="108">
                  <c:v>6036.9652125530201</c:v>
                </c:pt>
                <c:pt idx="109">
                  <c:v>6023.7434981269653</c:v>
                </c:pt>
                <c:pt idx="110">
                  <c:v>6025.826049582387</c:v>
                </c:pt>
                <c:pt idx="111">
                  <c:v>6112.1629137557456</c:v>
                </c:pt>
                <c:pt idx="112">
                  <c:v>5812.801306416909</c:v>
                </c:pt>
                <c:pt idx="113">
                  <c:v>5980.6228203503042</c:v>
                </c:pt>
                <c:pt idx="114">
                  <c:v>6278.5725225716724</c:v>
                </c:pt>
                <c:pt idx="115">
                  <c:v>5910.3888071339261</c:v>
                </c:pt>
                <c:pt idx="116">
                  <c:v>6116.4189327556633</c:v>
                </c:pt>
                <c:pt idx="117">
                  <c:v>6314.7489915864444</c:v>
                </c:pt>
                <c:pt idx="118">
                  <c:v>6053.8315387019093</c:v>
                </c:pt>
                <c:pt idx="119">
                  <c:v>5616.9637070976041</c:v>
                </c:pt>
                <c:pt idx="120">
                  <c:v>5723.4628847612421</c:v>
                </c:pt>
                <c:pt idx="121">
                  <c:v>5531.5557119606692</c:v>
                </c:pt>
                <c:pt idx="122">
                  <c:v>5722.1905693864719</c:v>
                </c:pt>
                <c:pt idx="123">
                  <c:v>5798.0459957764988</c:v>
                </c:pt>
                <c:pt idx="124">
                  <c:v>5648.6327780888341</c:v>
                </c:pt>
                <c:pt idx="125">
                  <c:v>6096.4181976350264</c:v>
                </c:pt>
                <c:pt idx="126">
                  <c:v>5701.7673854580953</c:v>
                </c:pt>
                <c:pt idx="127">
                  <c:v>5728.3851826031705</c:v>
                </c:pt>
                <c:pt idx="128">
                  <c:v>6146.3792248775717</c:v>
                </c:pt>
                <c:pt idx="129">
                  <c:v>5198.1751008538304</c:v>
                </c:pt>
                <c:pt idx="130">
                  <c:v>4924.8821220212349</c:v>
                </c:pt>
                <c:pt idx="131">
                  <c:v>5865.9465039958031</c:v>
                </c:pt>
                <c:pt idx="132">
                  <c:v>5623.5021009305783</c:v>
                </c:pt>
                <c:pt idx="133">
                  <c:v>5657.869472081431</c:v>
                </c:pt>
                <c:pt idx="134">
                  <c:v>5830.9288241720205</c:v>
                </c:pt>
                <c:pt idx="135">
                  <c:v>5456.9700477180577</c:v>
                </c:pt>
                <c:pt idx="136">
                  <c:v>5621.2152565870556</c:v>
                </c:pt>
                <c:pt idx="137">
                  <c:v>5322.7520109009956</c:v>
                </c:pt>
                <c:pt idx="138">
                  <c:v>5379.0360188339655</c:v>
                </c:pt>
                <c:pt idx="139">
                  <c:v>5141.9815527381588</c:v>
                </c:pt>
                <c:pt idx="140">
                  <c:v>4997.4131474002743</c:v>
                </c:pt>
                <c:pt idx="141">
                  <c:v>5293.1757445032499</c:v>
                </c:pt>
                <c:pt idx="142">
                  <c:v>4669.2542993705065</c:v>
                </c:pt>
                <c:pt idx="143">
                  <c:v>5467.8290463805752</c:v>
                </c:pt>
                <c:pt idx="144">
                  <c:v>6468.2499729416686</c:v>
                </c:pt>
                <c:pt idx="145">
                  <c:v>6625.8159107890961</c:v>
                </c:pt>
                <c:pt idx="146">
                  <c:v>6256.9419144355252</c:v>
                </c:pt>
                <c:pt idx="147">
                  <c:v>6492.0225825083007</c:v>
                </c:pt>
                <c:pt idx="148">
                  <c:v>6809.8534550912909</c:v>
                </c:pt>
                <c:pt idx="149">
                  <c:v>5880.3551334729427</c:v>
                </c:pt>
                <c:pt idx="150">
                  <c:v>6267.9163187304857</c:v>
                </c:pt>
                <c:pt idx="151">
                  <c:v>6384.321791636562</c:v>
                </c:pt>
                <c:pt idx="152">
                  <c:v>6035.8425765631227</c:v>
                </c:pt>
                <c:pt idx="153">
                  <c:v>6229.7323039862949</c:v>
                </c:pt>
                <c:pt idx="154">
                  <c:v>5788.2439749794576</c:v>
                </c:pt>
                <c:pt idx="155">
                  <c:v>5881.4023811109364</c:v>
                </c:pt>
                <c:pt idx="156">
                  <c:v>5253.8987851974725</c:v>
                </c:pt>
                <c:pt idx="157">
                  <c:v>5866.2528600016876</c:v>
                </c:pt>
                <c:pt idx="158">
                  <c:v>5804.430411689299</c:v>
                </c:pt>
                <c:pt idx="159">
                  <c:v>5835.6019332721444</c:v>
                </c:pt>
                <c:pt idx="160">
                  <c:v>5518.0238013059115</c:v>
                </c:pt>
                <c:pt idx="161">
                  <c:v>5409.6839279011247</c:v>
                </c:pt>
                <c:pt idx="162">
                  <c:v>5278.0861408537248</c:v>
                </c:pt>
                <c:pt idx="163">
                  <c:v>5107.7269212319497</c:v>
                </c:pt>
                <c:pt idx="164">
                  <c:v>5053.6218930248278</c:v>
                </c:pt>
                <c:pt idx="165">
                  <c:v>5185.5420669193945</c:v>
                </c:pt>
                <c:pt idx="166">
                  <c:v>4410.5546246473232</c:v>
                </c:pt>
                <c:pt idx="167">
                  <c:v>4643.23491370342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458-4198-AA84-92CEB696A6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655525824"/>
        <c:axId val="1655531648"/>
      </c:lineChart>
      <c:dateAx>
        <c:axId val="16555258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Month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[$-409]mmmm\ d\,\ yyyy;@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55531648"/>
        <c:crosses val="autoZero"/>
        <c:auto val="1"/>
        <c:lblOffset val="100"/>
        <c:baseTimeUnit val="months"/>
      </c:dateAx>
      <c:valAx>
        <c:axId val="16555316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ate per 1,000,000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555258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1ACB7B-9F0F-CB44-517A-BA478C1C8A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281059A-91EA-4F1C-C817-BCF1A665B5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9B1130-3365-DDB0-FE9D-50935B6EB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09D2F-3BC1-422D-80FB-D38DB1A0D757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502AAC-F30A-35A3-54A1-80A254AA90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101C50-2A2D-1B7E-32B2-9934678784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409E4-E9B1-4D23-A65C-E24986A92B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019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5CF551-ECA2-0BA5-776A-EA447C5176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4EAE60B-B896-EC07-A9D3-A326D5BB67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A669E9-96EE-A5D9-FC6E-8DF10FB93E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09D2F-3BC1-422D-80FB-D38DB1A0D757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86565D-2D76-1C56-2DC5-A0478E4C1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B29497-C4FB-BFDC-7824-4BDF84FA8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409E4-E9B1-4D23-A65C-E24986A92B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57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645D5FD-BCCB-6B1B-D395-DB10F214172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1519C2-748A-88D2-BD76-576B20CBEB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C35F67-5F20-F14A-2FD5-D2881BA1F0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09D2F-3BC1-422D-80FB-D38DB1A0D757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73B54F-AE8E-111E-08D1-8841267F5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EACA44-8617-FC9B-3079-21F825EBCB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409E4-E9B1-4D23-A65C-E24986A92B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901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6001FE-0DE5-58C2-E86B-26F1A0D66F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8DF8D3-B2FA-FB2A-B822-2D63AAED8C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A5E8BD-00D4-D03B-7914-A21B96819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09D2F-3BC1-422D-80FB-D38DB1A0D757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185091-0E7E-0526-4C38-751E21132F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102647-BC33-011B-CD43-860554A914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409E4-E9B1-4D23-A65C-E24986A92B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351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17E567-128E-BF00-7672-6DFDBA1A7F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410A25-8EA0-C1B7-571F-EBBE9EC80C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206928-1491-52A5-D8FC-BC8A9890ED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09D2F-3BC1-422D-80FB-D38DB1A0D757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445A1C-BA9B-53F3-66E0-4679114274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E0C6DA-7C5F-31D7-2B33-F62EBF02B2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409E4-E9B1-4D23-A65C-E24986A92B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448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B36C71-C496-737A-36A0-F8F6C1E5D5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9C9D02-9E6E-7D24-D1B5-0C81A92028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B87D2B-E226-0330-2630-75770FBC70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66D04E-B729-690B-F92D-028225C60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09D2F-3BC1-422D-80FB-D38DB1A0D757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3BEC53-566B-4630-D2A6-8C6B036EC8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0C6C88-1BFD-B275-BFCE-CAF837D44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409E4-E9B1-4D23-A65C-E24986A92B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22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0D5C88-FEF7-ABC3-5127-1680742433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9B53A1-9961-BED5-57B5-EB2C7D6AB9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D0CE33-9170-89F1-D116-297648526A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59874A0-5427-4F45-83C1-25D2822894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0C9305-DCE1-B659-407E-9138CCDDBC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4E83BAA-7E15-D61B-A968-C41FF2B37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09D2F-3BC1-422D-80FB-D38DB1A0D757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E671B53-0222-6AE7-19A8-BFD3246C7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FD0C41-5DBA-0D14-1373-6654F5F103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409E4-E9B1-4D23-A65C-E24986A92B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991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C0DD17-15E5-5AFC-90FB-EC8E060875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541F1D-79D7-68B1-D303-1F1A77AD1A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09D2F-3BC1-422D-80FB-D38DB1A0D757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32F22C-EC12-1D31-DACB-DA7AB69FC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02ED552-5B39-197D-8CA9-72955D5FE1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409E4-E9B1-4D23-A65C-E24986A92B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57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095973E-C182-091F-356C-9D0FC1998B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09D2F-3BC1-422D-80FB-D38DB1A0D757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490CA25-3A6D-E7B5-8882-953DB8332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EBCCD04-9DA7-0040-A2DC-74886DE27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409E4-E9B1-4D23-A65C-E24986A92B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269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E21EA2-E55A-8675-CBD0-5545E3A49A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D3CBB3-0B25-B58A-ED13-8E75B95120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AB7E9D-9491-DE65-0EB9-A0865B4733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2B11C9-580F-984B-5304-F7C782AE0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09D2F-3BC1-422D-80FB-D38DB1A0D757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A05DDE-478C-4D58-168C-F1FF87E13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6C3024-B729-55A6-8257-8B27F48A3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409E4-E9B1-4D23-A65C-E24986A92B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406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87FC18-8E10-47E2-A9C4-2FE5BD99B7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8153F5-DAD1-9D31-B58C-6912FDB9D7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FE47A9-55E9-F1C6-5E7E-F15F877944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9914EB-18AE-FA3E-FC25-7B75DB42A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09D2F-3BC1-422D-80FB-D38DB1A0D757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3E4155-A280-DD6D-E132-54DC12267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799ED2-BB2B-65C4-D0C6-05AE81A9E3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409E4-E9B1-4D23-A65C-E24986A92B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393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650992B-BA18-FA78-C544-C0E2E2A9D3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BEA85B-5CEF-E843-6DBA-753A0126A4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47D2A4-259F-692D-DA04-1157D33B4F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F09D2F-3BC1-422D-80FB-D38DB1A0D757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9268E8-31D9-02C0-1F84-1FDC69157B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C42231-9F53-062B-E097-777B75B37A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5409E4-E9B1-4D23-A65C-E24986A92B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822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46F8B918-C61F-4309-BB12-CD6484EC1743}"/>
              </a:ext>
            </a:extLst>
          </p:cNvPr>
          <p:cNvGraphicFramePr>
            <a:graphicFrameLocks/>
          </p:cNvGraphicFramePr>
          <p:nvPr/>
        </p:nvGraphicFramePr>
        <p:xfrm>
          <a:off x="1680507" y="955589"/>
          <a:ext cx="8756833" cy="48891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433F346E-D557-4810-9EC2-009E16E0CD84}"/>
              </a:ext>
            </a:extLst>
          </p:cNvPr>
          <p:cNvCxnSpPr>
            <a:cxnSpLocks/>
          </p:cNvCxnSpPr>
          <p:nvPr/>
        </p:nvCxnSpPr>
        <p:spPr>
          <a:xfrm>
            <a:off x="7142208" y="1491049"/>
            <a:ext cx="28833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C3AE885E-E39D-48DB-8C9F-D8BE923C1EAA}"/>
              </a:ext>
            </a:extLst>
          </p:cNvPr>
          <p:cNvCxnSpPr>
            <a:cxnSpLocks/>
          </p:cNvCxnSpPr>
          <p:nvPr/>
        </p:nvCxnSpPr>
        <p:spPr>
          <a:xfrm>
            <a:off x="8417012" y="1491049"/>
            <a:ext cx="28833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C4E266C8-6B33-71D8-8425-E580EF82EB25}"/>
              </a:ext>
            </a:extLst>
          </p:cNvPr>
          <p:cNvSpPr txBox="1"/>
          <p:nvPr/>
        </p:nvSpPr>
        <p:spPr>
          <a:xfrm>
            <a:off x="354227" y="350108"/>
            <a:ext cx="1989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5 Figure</a:t>
            </a:r>
          </a:p>
        </p:txBody>
      </p:sp>
    </p:spTree>
    <p:extLst>
      <p:ext uri="{BB962C8B-B14F-4D97-AF65-F5344CB8AC3E}">
        <p14:creationId xmlns:p14="http://schemas.microsoft.com/office/powerpoint/2010/main" val="13456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Women's College Hospita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u, Cherry</dc:creator>
  <cp:lastModifiedBy>Chu, Cherry</cp:lastModifiedBy>
  <cp:revision>1</cp:revision>
  <dcterms:created xsi:type="dcterms:W3CDTF">2023-07-26T15:47:28Z</dcterms:created>
  <dcterms:modified xsi:type="dcterms:W3CDTF">2023-07-26T15:47:36Z</dcterms:modified>
</cp:coreProperties>
</file>